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06" r:id="rId2"/>
  </p:sldIdLst>
  <p:sldSz cx="9144000" cy="6858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1644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-48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358192-456B-42DC-9A22-5439F693A28D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265F06-BF1C-4203-991A-D32F71E128C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15630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835696" y="1181151"/>
            <a:ext cx="6048672" cy="5560217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Rectangle 2"/>
          <p:cNvSpPr/>
          <p:nvPr/>
        </p:nvSpPr>
        <p:spPr>
          <a:xfrm>
            <a:off x="186813" y="111503"/>
            <a:ext cx="8928992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b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GB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GB" sz="1100" b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. KEGG </a:t>
            </a:r>
            <a:r>
              <a:rPr lang="en-GB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thway map for metabolism of </a:t>
            </a:r>
            <a:r>
              <a:rPr lang="en-GB" sz="1100" b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ntothenate</a:t>
            </a:r>
            <a:r>
              <a:rPr lang="en-GB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CoA in </a:t>
            </a:r>
            <a:r>
              <a:rPr lang="en-GB" sz="1100" b="1" i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lautia </a:t>
            </a:r>
            <a:r>
              <a:rPr lang="en-GB" sz="1100" b="1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ydrogenotrophica</a:t>
            </a:r>
            <a:r>
              <a:rPr lang="en-GB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Genes present in the </a:t>
            </a:r>
            <a:r>
              <a:rPr lang="en-GB" sz="11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fferentially expressed gene</a:t>
            </a:r>
            <a:r>
              <a:rPr lang="en-GB" sz="1100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ist are highlighted with those with up regulated expression in the co-culture compared to the mono-culture in red and those with down regulated expression in green. Genes with KEGG </a:t>
            </a:r>
            <a:r>
              <a:rPr lang="en-GB" sz="11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rthologs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ound by KAAS-KEGG, but no significant change in expression, are highlighted in blue.</a:t>
            </a:r>
            <a:endParaRPr lang="en-GB" sz="11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205488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768</TotalTime>
  <Words>71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University of Aberdee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RI014</dc:creator>
  <cp:lastModifiedBy>Mukhopadhya, Indrani</cp:lastModifiedBy>
  <cp:revision>595</cp:revision>
  <cp:lastPrinted>2017-08-24T09:34:40Z</cp:lastPrinted>
  <dcterms:created xsi:type="dcterms:W3CDTF">2013-01-18T16:14:41Z</dcterms:created>
  <dcterms:modified xsi:type="dcterms:W3CDTF">2018-03-09T16:49:49Z</dcterms:modified>
</cp:coreProperties>
</file>